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865" r:id="rId2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CFF"/>
    <a:srgbClr val="00B5FF"/>
    <a:srgbClr val="A20305"/>
    <a:srgbClr val="A30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857"/>
    <p:restoredTop sz="95551"/>
  </p:normalViewPr>
  <p:slideViewPr>
    <p:cSldViewPr snapToGrid="0" snapToObjects="1">
      <p:cViewPr varScale="1">
        <p:scale>
          <a:sx n="80" d="100"/>
          <a:sy n="80" d="100"/>
        </p:scale>
        <p:origin x="26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5A565-0660-F24A-9241-43E2B99AF08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F7975-6509-8042-909C-D5380521D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10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4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2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49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6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47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9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7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51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"/><Relationship Id="rId5" Type="http://schemas.openxmlformats.org/officeDocument/2006/relationships/image" Target="../media/image4.tiff"/><Relationship Id="rId10" Type="http://schemas.openxmlformats.org/officeDocument/2006/relationships/image" Target="../media/image9.tif"/><Relationship Id="rId4" Type="http://schemas.openxmlformats.org/officeDocument/2006/relationships/image" Target="../media/image3.png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Group 72">
            <a:extLst>
              <a:ext uri="{FF2B5EF4-FFF2-40B4-BE49-F238E27FC236}">
                <a16:creationId xmlns:a16="http://schemas.microsoft.com/office/drawing/2014/main" id="{0A0CE8BC-07BB-3740-A19E-D45BF3F17B98}"/>
              </a:ext>
            </a:extLst>
          </p:cNvPr>
          <p:cNvGrpSpPr/>
          <p:nvPr/>
        </p:nvGrpSpPr>
        <p:grpSpPr>
          <a:xfrm>
            <a:off x="13922" y="3311164"/>
            <a:ext cx="5683173" cy="1788504"/>
            <a:chOff x="541694" y="658637"/>
            <a:chExt cx="11432146" cy="3172327"/>
          </a:xfrm>
        </p:grpSpPr>
        <p:pic>
          <p:nvPicPr>
            <p:cNvPr id="74" name="Picture 73" descr="A graph of a number of dots&#10;&#10;Description automatically generated">
              <a:extLst>
                <a:ext uri="{FF2B5EF4-FFF2-40B4-BE49-F238E27FC236}">
                  <a16:creationId xmlns:a16="http://schemas.microsoft.com/office/drawing/2014/main" id="{B1BDBE23-1E65-BB4D-93D0-FA4B1B1B592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965"/>
            <a:stretch/>
          </p:blipFill>
          <p:spPr>
            <a:xfrm>
              <a:off x="541694" y="658637"/>
              <a:ext cx="3532364" cy="2770363"/>
            </a:xfrm>
            <a:prstGeom prst="rect">
              <a:avLst/>
            </a:prstGeom>
          </p:spPr>
        </p:pic>
        <p:pic>
          <p:nvPicPr>
            <p:cNvPr id="75" name="Picture 74" descr="A graph with black dots&#10;&#10;Description automatically generated">
              <a:extLst>
                <a:ext uri="{FF2B5EF4-FFF2-40B4-BE49-F238E27FC236}">
                  <a16:creationId xmlns:a16="http://schemas.microsoft.com/office/drawing/2014/main" id="{02B230E6-47A4-EA45-B454-62984EF7BD6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1584" y="658637"/>
              <a:ext cx="3532365" cy="2825892"/>
            </a:xfrm>
            <a:prstGeom prst="rect">
              <a:avLst/>
            </a:prstGeom>
          </p:spPr>
        </p:pic>
        <p:pic>
          <p:nvPicPr>
            <p:cNvPr id="76" name="Picture 75" descr="A graph with black dots&#10;&#10;Description automatically generated">
              <a:extLst>
                <a:ext uri="{FF2B5EF4-FFF2-40B4-BE49-F238E27FC236}">
                  <a16:creationId xmlns:a16="http://schemas.microsoft.com/office/drawing/2014/main" id="{6BF947A2-99E6-1B48-B668-6823F9A2F02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965"/>
            <a:stretch/>
          </p:blipFill>
          <p:spPr>
            <a:xfrm>
              <a:off x="8441475" y="658637"/>
              <a:ext cx="3532365" cy="2770363"/>
            </a:xfrm>
            <a:prstGeom prst="rect">
              <a:avLst/>
            </a:prstGeom>
          </p:spPr>
        </p:pic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2F0C500C-9D6D-814A-B9E6-DC131D688ECC}"/>
                </a:ext>
              </a:extLst>
            </p:cNvPr>
            <p:cNvSpPr txBox="1"/>
            <p:nvPr/>
          </p:nvSpPr>
          <p:spPr>
            <a:xfrm>
              <a:off x="1371895" y="3452814"/>
              <a:ext cx="1797840" cy="3781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allmark EMT</a:t>
              </a:r>
              <a:endParaRPr lang="en-I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A7CC5E7B-63B4-B241-B030-6D54349B5EE4}"/>
                </a:ext>
              </a:extLst>
            </p:cNvPr>
            <p:cNvSpPr txBox="1"/>
            <p:nvPr/>
          </p:nvSpPr>
          <p:spPr>
            <a:xfrm>
              <a:off x="4781277" y="3439308"/>
              <a:ext cx="3179015" cy="3781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pithelial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Mesenchymal</a:t>
              </a:r>
              <a:endParaRPr lang="en-I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95F19B77-472B-F04D-89BC-B83984B65F3D}"/>
                </a:ext>
              </a:extLst>
            </p:cNvPr>
            <p:cNvSpPr txBox="1"/>
            <p:nvPr/>
          </p:nvSpPr>
          <p:spPr>
            <a:xfrm>
              <a:off x="9865475" y="3431461"/>
              <a:ext cx="948331" cy="3781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EMT</a:t>
              </a:r>
              <a:endParaRPr lang="en-I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itle 1">
            <a:extLst>
              <a:ext uri="{FF2B5EF4-FFF2-40B4-BE49-F238E27FC236}">
                <a16:creationId xmlns:a16="http://schemas.microsoft.com/office/drawing/2014/main" id="{2463696D-816E-A841-BDBE-B3DB8D31574B}"/>
              </a:ext>
            </a:extLst>
          </p:cNvPr>
          <p:cNvSpPr txBox="1">
            <a:spLocks/>
          </p:cNvSpPr>
          <p:nvPr/>
        </p:nvSpPr>
        <p:spPr>
          <a:xfrm>
            <a:off x="0" y="49936"/>
            <a:ext cx="3247697" cy="3537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7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8FF6E1A-B375-6D4D-9EF9-0A7D3F61BEC5}"/>
              </a:ext>
            </a:extLst>
          </p:cNvPr>
          <p:cNvSpPr txBox="1"/>
          <p:nvPr/>
        </p:nvSpPr>
        <p:spPr>
          <a:xfrm>
            <a:off x="-29386" y="3147664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D2D45F2-8D40-FE42-A82A-AD3C0ADD35C6}"/>
              </a:ext>
            </a:extLst>
          </p:cNvPr>
          <p:cNvSpPr txBox="1"/>
          <p:nvPr/>
        </p:nvSpPr>
        <p:spPr>
          <a:xfrm>
            <a:off x="-17927" y="313046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0DF7FCA-EAEA-6841-85D8-13ACB2532D12}"/>
              </a:ext>
            </a:extLst>
          </p:cNvPr>
          <p:cNvSpPr txBox="1"/>
          <p:nvPr/>
        </p:nvSpPr>
        <p:spPr>
          <a:xfrm>
            <a:off x="1762298" y="3126952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grpSp>
        <p:nvGrpSpPr>
          <p:cNvPr id="83" name="Group 82">
            <a:extLst>
              <a:ext uri="{FF2B5EF4-FFF2-40B4-BE49-F238E27FC236}">
                <a16:creationId xmlns:a16="http://schemas.microsoft.com/office/drawing/2014/main" id="{29A4410F-BE2D-D144-BA74-CAF80E25095B}"/>
              </a:ext>
            </a:extLst>
          </p:cNvPr>
          <p:cNvGrpSpPr/>
          <p:nvPr/>
        </p:nvGrpSpPr>
        <p:grpSpPr>
          <a:xfrm>
            <a:off x="5650749" y="3307340"/>
            <a:ext cx="1529331" cy="2718255"/>
            <a:chOff x="3995831" y="297382"/>
            <a:chExt cx="2221775" cy="3920699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54B76B3-CD3F-A247-BED6-29FFC857969A}"/>
                </a:ext>
              </a:extLst>
            </p:cNvPr>
            <p:cNvSpPr txBox="1"/>
            <p:nvPr/>
          </p:nvSpPr>
          <p:spPr>
            <a:xfrm>
              <a:off x="4267633" y="3812134"/>
              <a:ext cx="731662" cy="4059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D73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36BDE31B-5D79-8445-8650-58D16D36A5DB}"/>
                </a:ext>
              </a:extLst>
            </p:cNvPr>
            <p:cNvGrpSpPr/>
            <p:nvPr/>
          </p:nvGrpSpPr>
          <p:grpSpPr>
            <a:xfrm>
              <a:off x="3995831" y="297382"/>
              <a:ext cx="2221775" cy="3608372"/>
              <a:chOff x="3995831" y="297382"/>
              <a:chExt cx="2221775" cy="3608372"/>
            </a:xfrm>
          </p:grpSpPr>
          <p:pic>
            <p:nvPicPr>
              <p:cNvPr id="86" name="Picture 85">
                <a:extLst>
                  <a:ext uri="{FF2B5EF4-FFF2-40B4-BE49-F238E27FC236}">
                    <a16:creationId xmlns:a16="http://schemas.microsoft.com/office/drawing/2014/main" id="{6A1B6093-3CE1-1442-AEED-4EC32D37C7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8677" b="5116"/>
              <a:stretch/>
            </p:blipFill>
            <p:spPr>
              <a:xfrm>
                <a:off x="4413092" y="556057"/>
                <a:ext cx="1708049" cy="1510772"/>
              </a:xfrm>
              <a:prstGeom prst="rect">
                <a:avLst/>
              </a:prstGeom>
            </p:spPr>
          </p:pic>
          <p:pic>
            <p:nvPicPr>
              <p:cNvPr id="87" name="Picture 86">
                <a:extLst>
                  <a:ext uri="{FF2B5EF4-FFF2-40B4-BE49-F238E27FC236}">
                    <a16:creationId xmlns:a16="http://schemas.microsoft.com/office/drawing/2014/main" id="{A835F58F-42CA-5A48-9B0D-2623DD0A28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9285" b="5116"/>
              <a:stretch/>
            </p:blipFill>
            <p:spPr>
              <a:xfrm>
                <a:off x="4436629" y="2283680"/>
                <a:ext cx="1695274" cy="1510772"/>
              </a:xfrm>
              <a:prstGeom prst="rect">
                <a:avLst/>
              </a:prstGeom>
            </p:spPr>
          </p:pic>
          <p:cxnSp>
            <p:nvCxnSpPr>
              <p:cNvPr id="88" name="Straight Arrow Connector 87">
                <a:extLst>
                  <a:ext uri="{FF2B5EF4-FFF2-40B4-BE49-F238E27FC236}">
                    <a16:creationId xmlns:a16="http://schemas.microsoft.com/office/drawing/2014/main" id="{17B87242-EA82-074A-BC5E-D5A0D73FF79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343966" y="473984"/>
                <a:ext cx="15993" cy="33502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9" name="Straight Arrow Connector 88">
                <a:extLst>
                  <a:ext uri="{FF2B5EF4-FFF2-40B4-BE49-F238E27FC236}">
                    <a16:creationId xmlns:a16="http://schemas.microsoft.com/office/drawing/2014/main" id="{FE7DD2B1-69D0-0C4C-ADD6-C757102748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55841" y="3824270"/>
                <a:ext cx="185709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88F55C02-8AAD-5C41-9A72-ECFE48397A34}"/>
                  </a:ext>
                </a:extLst>
              </p:cNvPr>
              <p:cNvSpPr txBox="1"/>
              <p:nvPr/>
            </p:nvSpPr>
            <p:spPr>
              <a:xfrm rot="16200000">
                <a:off x="3792576" y="3312536"/>
                <a:ext cx="796473" cy="3899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SSC-A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8A0E6C50-58D9-0D41-9FC7-AA3B92011F4B}"/>
                  </a:ext>
                </a:extLst>
              </p:cNvPr>
              <p:cNvSpPr txBox="1"/>
              <p:nvPr/>
            </p:nvSpPr>
            <p:spPr>
              <a:xfrm>
                <a:off x="4757498" y="297382"/>
                <a:ext cx="1195142" cy="3551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uciferase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E9A360FE-667A-964F-93BC-326E24E8C093}"/>
                  </a:ext>
                </a:extLst>
              </p:cNvPr>
              <p:cNvSpPr txBox="1"/>
              <p:nvPr/>
            </p:nvSpPr>
            <p:spPr>
              <a:xfrm>
                <a:off x="4655589" y="2057034"/>
                <a:ext cx="1325555" cy="3551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lug + Sox9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16F32EF3-7262-7D45-9F02-197EF9ADD767}"/>
                  </a:ext>
                </a:extLst>
              </p:cNvPr>
              <p:cNvSpPr txBox="1"/>
              <p:nvPr/>
            </p:nvSpPr>
            <p:spPr>
              <a:xfrm>
                <a:off x="5409481" y="613402"/>
                <a:ext cx="808125" cy="4059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0.37%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988CAA56-181B-CE4A-B2FC-0FCB674C4C89}"/>
                  </a:ext>
                </a:extLst>
              </p:cNvPr>
              <p:cNvSpPr txBox="1"/>
              <p:nvPr/>
            </p:nvSpPr>
            <p:spPr>
              <a:xfrm>
                <a:off x="5399194" y="2358345"/>
                <a:ext cx="808125" cy="4059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23.5%</a:t>
                </a:r>
              </a:p>
            </p:txBody>
          </p:sp>
        </p:grpSp>
      </p:grpSp>
      <p:pic>
        <p:nvPicPr>
          <p:cNvPr id="96" name="Picture 95">
            <a:extLst>
              <a:ext uri="{FF2B5EF4-FFF2-40B4-BE49-F238E27FC236}">
                <a16:creationId xmlns:a16="http://schemas.microsoft.com/office/drawing/2014/main" id="{9BF3A338-B6FF-0F45-B596-03325E49D04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0214" r="1631"/>
          <a:stretch/>
        </p:blipFill>
        <p:spPr>
          <a:xfrm>
            <a:off x="2641600" y="5459622"/>
            <a:ext cx="1967496" cy="2136699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0E21FA17-612B-0742-9500-0F20994DD692}"/>
              </a:ext>
            </a:extLst>
          </p:cNvPr>
          <p:cNvSpPr txBox="1"/>
          <p:nvPr/>
        </p:nvSpPr>
        <p:spPr>
          <a:xfrm>
            <a:off x="2497810" y="5118879"/>
            <a:ext cx="393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.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2AC7E19-1F91-254D-8EF8-F2B28F24B6B1}"/>
              </a:ext>
            </a:extLst>
          </p:cNvPr>
          <p:cNvSpPr txBox="1"/>
          <p:nvPr/>
        </p:nvSpPr>
        <p:spPr>
          <a:xfrm>
            <a:off x="5509554" y="3084450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B9FC3FCE-6512-9142-BDF9-BEF5950E4BC6}"/>
              </a:ext>
            </a:extLst>
          </p:cNvPr>
          <p:cNvGrpSpPr/>
          <p:nvPr/>
        </p:nvGrpSpPr>
        <p:grpSpPr>
          <a:xfrm>
            <a:off x="179499" y="5149466"/>
            <a:ext cx="2445172" cy="2317586"/>
            <a:chOff x="370643" y="4620168"/>
            <a:chExt cx="4008165" cy="3859577"/>
          </a:xfrm>
        </p:grpSpPr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A5C08112-A280-6549-99D8-7313C9988F01}"/>
                </a:ext>
              </a:extLst>
            </p:cNvPr>
            <p:cNvGrpSpPr/>
            <p:nvPr/>
          </p:nvGrpSpPr>
          <p:grpSpPr>
            <a:xfrm>
              <a:off x="469552" y="6553745"/>
              <a:ext cx="3622539" cy="543697"/>
              <a:chOff x="4127156" y="1136822"/>
              <a:chExt cx="3622539" cy="543697"/>
            </a:xfrm>
          </p:grpSpPr>
          <p:pic>
            <p:nvPicPr>
              <p:cNvPr id="100" name="Picture 99">
                <a:extLst>
                  <a:ext uri="{FF2B5EF4-FFF2-40B4-BE49-F238E27FC236}">
                    <a16:creationId xmlns:a16="http://schemas.microsoft.com/office/drawing/2014/main" id="{AFD611AC-01AD-7E44-A1B9-C5D5CFF5C6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57961" t="28368" r="8102" b="61061"/>
              <a:stretch/>
            </p:blipFill>
            <p:spPr>
              <a:xfrm>
                <a:off x="4127156" y="1136822"/>
                <a:ext cx="2866768" cy="54369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D0B69FC9-16A4-6042-8029-792FF9265410}"/>
                  </a:ext>
                </a:extLst>
              </p:cNvPr>
              <p:cNvSpPr txBox="1"/>
              <p:nvPr/>
            </p:nvSpPr>
            <p:spPr>
              <a:xfrm>
                <a:off x="6947751" y="1224004"/>
                <a:ext cx="801944" cy="3648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ox9</a:t>
                </a:r>
              </a:p>
            </p:txBody>
          </p:sp>
        </p:grpSp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E4EFA347-4477-3342-91F4-9842F28BAB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0059" t="21189" r="49034" b="70061"/>
            <a:stretch/>
          </p:blipFill>
          <p:spPr>
            <a:xfrm>
              <a:off x="469680" y="5217563"/>
              <a:ext cx="2866768" cy="5436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9324BFF7-9B3C-C14D-8950-94CBAE13E749}"/>
                </a:ext>
              </a:extLst>
            </p:cNvPr>
            <p:cNvSpPr txBox="1"/>
            <p:nvPr/>
          </p:nvSpPr>
          <p:spPr>
            <a:xfrm>
              <a:off x="3290275" y="5274425"/>
              <a:ext cx="875494" cy="364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-cad</a:t>
              </a:r>
            </a:p>
          </p:txBody>
        </p:sp>
        <p:pic>
          <p:nvPicPr>
            <p:cNvPr id="104" name="Picture 103">
              <a:extLst>
                <a:ext uri="{FF2B5EF4-FFF2-40B4-BE49-F238E27FC236}">
                  <a16:creationId xmlns:a16="http://schemas.microsoft.com/office/drawing/2014/main" id="{D487038C-D44D-6A49-A70E-D489FE809E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5828" t="48562" r="55707" b="44419"/>
            <a:stretch/>
          </p:blipFill>
          <p:spPr>
            <a:xfrm>
              <a:off x="469680" y="5900615"/>
              <a:ext cx="2866768" cy="5436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ED56D9BE-22A9-5842-80AB-0C821BB6638E}"/>
                </a:ext>
              </a:extLst>
            </p:cNvPr>
            <p:cNvSpPr txBox="1"/>
            <p:nvPr/>
          </p:nvSpPr>
          <p:spPr>
            <a:xfrm>
              <a:off x="3290275" y="5982192"/>
              <a:ext cx="814625" cy="364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wist</a:t>
              </a:r>
            </a:p>
          </p:txBody>
        </p:sp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5E4C5F24-3B8C-DF4C-BF81-2B94F7BC30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54644" t="35047" r="11868" b="55818"/>
            <a:stretch/>
          </p:blipFill>
          <p:spPr>
            <a:xfrm>
              <a:off x="469680" y="7925631"/>
              <a:ext cx="2866768" cy="5541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D912D961-6CA4-4F41-99E1-E97C926D3C6D}"/>
                </a:ext>
              </a:extLst>
            </p:cNvPr>
            <p:cNvSpPr txBox="1"/>
            <p:nvPr/>
          </p:nvSpPr>
          <p:spPr>
            <a:xfrm>
              <a:off x="3290275" y="7994395"/>
              <a:ext cx="1088533" cy="364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id="{D99A68C2-9A6B-7C47-BD83-4AEF45D9CD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9611" t="42450" r="48470" b="49858"/>
            <a:stretch/>
          </p:blipFill>
          <p:spPr>
            <a:xfrm>
              <a:off x="469552" y="7218776"/>
              <a:ext cx="2866768" cy="5402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37710158-FEBC-874C-9631-E4FC6CF592AF}"/>
                </a:ext>
              </a:extLst>
            </p:cNvPr>
            <p:cNvSpPr txBox="1"/>
            <p:nvPr/>
          </p:nvSpPr>
          <p:spPr>
            <a:xfrm>
              <a:off x="3298608" y="7330273"/>
              <a:ext cx="741076" cy="364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lug</a:t>
              </a:r>
            </a:p>
          </p:txBody>
        </p:sp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AF70659A-8C2A-5048-8B76-28EEFB4536C4}"/>
                </a:ext>
              </a:extLst>
            </p:cNvPr>
            <p:cNvGrpSpPr/>
            <p:nvPr/>
          </p:nvGrpSpPr>
          <p:grpSpPr>
            <a:xfrm>
              <a:off x="370643" y="4620168"/>
              <a:ext cx="3954162" cy="604698"/>
              <a:chOff x="4028119" y="564141"/>
              <a:chExt cx="3954162" cy="604698"/>
            </a:xfrm>
          </p:grpSpPr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6A1D937D-95DB-3B4A-BDE0-39A45D0BA1B6}"/>
                  </a:ext>
                </a:extLst>
              </p:cNvPr>
              <p:cNvSpPr txBox="1"/>
              <p:nvPr/>
            </p:nvSpPr>
            <p:spPr>
              <a:xfrm>
                <a:off x="4028119" y="825405"/>
                <a:ext cx="3954162" cy="343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uc   Twist   Zeb1  Sox9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9FC8BB5A-E850-D742-9D25-D48FF21E7507}"/>
                  </a:ext>
                </a:extLst>
              </p:cNvPr>
              <p:cNvSpPr txBox="1"/>
              <p:nvPr/>
            </p:nvSpPr>
            <p:spPr>
              <a:xfrm>
                <a:off x="6425684" y="564141"/>
                <a:ext cx="935694" cy="558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lug+</a:t>
                </a:r>
              </a:p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ox9</a:t>
                </a:r>
              </a:p>
            </p:txBody>
          </p:sp>
        </p:grp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479CD493-B150-A94E-9F49-5A92D3CDEEF1}"/>
              </a:ext>
            </a:extLst>
          </p:cNvPr>
          <p:cNvGrpSpPr/>
          <p:nvPr/>
        </p:nvGrpSpPr>
        <p:grpSpPr>
          <a:xfrm>
            <a:off x="51078" y="346087"/>
            <a:ext cx="4604892" cy="2768531"/>
            <a:chOff x="6049449" y="2118510"/>
            <a:chExt cx="6057067" cy="4351021"/>
          </a:xfrm>
        </p:grpSpPr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D40D9A44-2F48-6942-9996-BFD60AA36E8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rcRect l="2971" b="4753"/>
            <a:stretch/>
          </p:blipFill>
          <p:spPr>
            <a:xfrm>
              <a:off x="6391747" y="2118510"/>
              <a:ext cx="5714769" cy="3479539"/>
            </a:xfrm>
            <a:prstGeom prst="rect">
              <a:avLst/>
            </a:prstGeom>
          </p:spPr>
        </p:pic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2D1C993-C468-8F41-B63E-11B416F8D46A}"/>
                </a:ext>
              </a:extLst>
            </p:cNvPr>
            <p:cNvSpPr txBox="1"/>
            <p:nvPr/>
          </p:nvSpPr>
          <p:spPr>
            <a:xfrm rot="16200000">
              <a:off x="5334957" y="3764553"/>
              <a:ext cx="1716703" cy="2877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NT5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Expression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68DEF8F9-1700-BB48-9FFF-3E9983D23EB1}"/>
                </a:ext>
              </a:extLst>
            </p:cNvPr>
            <p:cNvSpPr/>
            <p:nvPr/>
          </p:nvSpPr>
          <p:spPr>
            <a:xfrm>
              <a:off x="6681457" y="5639036"/>
              <a:ext cx="253497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CC91BA0C-9862-4647-B0AB-DCA9483C7950}"/>
                </a:ext>
              </a:extLst>
            </p:cNvPr>
            <p:cNvSpPr txBox="1"/>
            <p:nvPr/>
          </p:nvSpPr>
          <p:spPr>
            <a:xfrm rot="20099956">
              <a:off x="6427213" y="5887915"/>
              <a:ext cx="899458" cy="3448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uminal 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04333F9-0487-7D48-80E4-780CC75B78C9}"/>
                </a:ext>
              </a:extLst>
            </p:cNvPr>
            <p:cNvSpPr txBox="1"/>
            <p:nvPr/>
          </p:nvSpPr>
          <p:spPr>
            <a:xfrm rot="20099956">
              <a:off x="7357614" y="5887915"/>
              <a:ext cx="890668" cy="3448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uminal 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E3202A87-AD0D-9340-9916-C8225949F1FD}"/>
                </a:ext>
              </a:extLst>
            </p:cNvPr>
            <p:cNvSpPr txBox="1"/>
            <p:nvPr/>
          </p:nvSpPr>
          <p:spPr>
            <a:xfrm rot="20099956">
              <a:off x="8587793" y="5887915"/>
              <a:ext cx="709642" cy="3448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ER2+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7C0EC1FB-C7A9-AB47-AF79-34956AE4CA05}"/>
                </a:ext>
              </a:extLst>
            </p:cNvPr>
            <p:cNvSpPr txBox="1"/>
            <p:nvPr/>
          </p:nvSpPr>
          <p:spPr>
            <a:xfrm rot="20099956">
              <a:off x="9663085" y="5887915"/>
              <a:ext cx="769119" cy="3448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NBC A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DB983A13-032D-0148-B99F-8810711B1180}"/>
                </a:ext>
              </a:extLst>
            </p:cNvPr>
            <p:cNvSpPr txBox="1"/>
            <p:nvPr/>
          </p:nvSpPr>
          <p:spPr>
            <a:xfrm rot="20099956">
              <a:off x="10903134" y="5887915"/>
              <a:ext cx="777910" cy="3448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NBC B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89B4323-8A27-0E45-94B5-D3F1EE3E9A69}"/>
                </a:ext>
              </a:extLst>
            </p:cNvPr>
            <p:cNvSpPr txBox="1"/>
            <p:nvPr/>
          </p:nvSpPr>
          <p:spPr>
            <a:xfrm rot="16200000">
              <a:off x="11411787" y="5797608"/>
              <a:ext cx="1056126" cy="2877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asal-like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00948551-7864-1448-9251-A640A94791F7}"/>
                </a:ext>
              </a:extLst>
            </p:cNvPr>
            <p:cNvSpPr/>
            <p:nvPr/>
          </p:nvSpPr>
          <p:spPr>
            <a:xfrm>
              <a:off x="6985494" y="5641501"/>
              <a:ext cx="1464713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04D36B8E-21AB-AC45-9C1F-0A86ED2F9479}"/>
                </a:ext>
              </a:extLst>
            </p:cNvPr>
            <p:cNvSpPr/>
            <p:nvPr/>
          </p:nvSpPr>
          <p:spPr>
            <a:xfrm>
              <a:off x="8469389" y="5643239"/>
              <a:ext cx="856851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E2D22F46-D8CD-8A4F-8DCB-9AD92C1342F9}"/>
                </a:ext>
              </a:extLst>
            </p:cNvPr>
            <p:cNvSpPr/>
            <p:nvPr/>
          </p:nvSpPr>
          <p:spPr>
            <a:xfrm>
              <a:off x="9352237" y="5639035"/>
              <a:ext cx="1304040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30C7ECF9-7B9E-A142-95A0-CC9728DDA4D7}"/>
                </a:ext>
              </a:extLst>
            </p:cNvPr>
            <p:cNvSpPr/>
            <p:nvPr/>
          </p:nvSpPr>
          <p:spPr>
            <a:xfrm>
              <a:off x="10682274" y="5636314"/>
              <a:ext cx="1176151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E3184C96-EDC7-4E44-A5FF-445B48ECFFDA}"/>
              </a:ext>
            </a:extLst>
          </p:cNvPr>
          <p:cNvSpPr txBox="1"/>
          <p:nvPr/>
        </p:nvSpPr>
        <p:spPr>
          <a:xfrm>
            <a:off x="3823032" y="3114292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13D2239-C37E-A940-BB5C-4D3B2703A9C7}"/>
              </a:ext>
            </a:extLst>
          </p:cNvPr>
          <p:cNvSpPr txBox="1"/>
          <p:nvPr/>
        </p:nvSpPr>
        <p:spPr>
          <a:xfrm>
            <a:off x="-41373" y="5114034"/>
            <a:ext cx="333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.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4475BD46-39A8-F946-AA6F-8E799D7DF304}"/>
              </a:ext>
            </a:extLst>
          </p:cNvPr>
          <p:cNvSpPr txBox="1"/>
          <p:nvPr/>
        </p:nvSpPr>
        <p:spPr>
          <a:xfrm>
            <a:off x="-23785" y="7567085"/>
            <a:ext cx="7298266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100" b="1" i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7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MP regulates CD73 expression on human breast cancer cell lines</a:t>
            </a:r>
            <a:r>
              <a:rPr lang="en-US" sz="1100" b="1" dirty="0">
                <a:latin typeface="Times" pitchFamily="2" charset="0"/>
                <a:ea typeface="Times" pitchFamily="2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Expression of CD73 (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NT5E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from transcriptomic data obtained from the CCLE for the indicated breast cancer cell lines. (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B-D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Data from panel A represented as correlation plots between CD73 (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NT5E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against (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1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ssGSEA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based Hallmark EMT score; (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1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ssGSEA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based Mesenchymal score – Epithelial score (higher values indicate a higher mesenchymal nature); (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1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ssGSEA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based </a:t>
            </a:r>
            <a:r>
              <a:rPr lang="en-US" sz="11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pEMT</a:t>
            </a:r>
            <a:r>
              <a:rPr lang="en-US" sz="11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 score. Numbers on top of each panel represent the correlation co-efficient and p-value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E-G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MCF7RAS cells expressing doxycycline-controlled control Luciferase or the indicated EMT-TFs were treated with doxycycline for 4 days to induce EMP. (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Flow cytometry plots for the indicated cell lines representing the % of cells expressing CD73. Data represent four independent experiments. (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Western blot for the indicated markers. Data represent four independent experiments. (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Bar graph representing percentage of cells expressing CD73. Data represent four independent experiments. Data represent SEM, two-tailed unpaired t-test, </a:t>
            </a:r>
            <a:r>
              <a:rPr lang="en-US" sz="1100" i="1" kern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**, p&lt;0.01.</a:t>
            </a:r>
            <a:endParaRPr lang="en-US" sz="11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482756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2</TotalTime>
  <Words>257</Words>
  <Application>Microsoft Macintosh PowerPoint</Application>
  <PresentationFormat>Custom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#2</dc:title>
  <dc:creator>Microsoft Office User</dc:creator>
  <cp:lastModifiedBy>Anushka Dongre</cp:lastModifiedBy>
  <cp:revision>418</cp:revision>
  <dcterms:created xsi:type="dcterms:W3CDTF">2023-02-11T23:37:55Z</dcterms:created>
  <dcterms:modified xsi:type="dcterms:W3CDTF">2026-05-11T01:29:16Z</dcterms:modified>
</cp:coreProperties>
</file>